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8" r:id="rId2"/>
    <p:sldId id="257" r:id="rId3"/>
    <p:sldId id="259" r:id="rId4"/>
    <p:sldId id="260" r:id="rId5"/>
  </p:sldIdLst>
  <p:sldSz cx="6254750" cy="4846638"/>
  <p:notesSz cx="6858000" cy="9144000"/>
  <p:defaultTextStyle>
    <a:defPPr>
      <a:defRPr lang="en-US"/>
    </a:defPPr>
    <a:lvl1pPr marL="0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306964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613928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920892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227856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1534820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1841784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2148749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2455713" algn="l" defTabSz="30696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7">
          <p15:clr>
            <a:srgbClr val="A4A3A4"/>
          </p15:clr>
        </p15:guide>
        <p15:guide id="2" pos="197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 showGuides="1">
      <p:cViewPr varScale="1">
        <p:scale>
          <a:sx n="149" d="100"/>
          <a:sy n="149" d="100"/>
        </p:scale>
        <p:origin x="2508" y="108"/>
      </p:cViewPr>
      <p:guideLst>
        <p:guide orient="horz" pos="1527"/>
        <p:guide pos="197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13FF66-D7AE-488C-A5FE-A09ED928D4F8}" type="datetimeFigureOut">
              <a:rPr lang="en-GB" smtClean="0"/>
              <a:t>14/1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8275" y="1143000"/>
            <a:ext cx="3981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2ED1EC-827C-4627-851C-518559D4DA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3347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E2ED1EC-827C-4627-851C-518559D4DA50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105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505600"/>
            <a:ext cx="5316538" cy="1038886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8216" y="2746430"/>
            <a:ext cx="4378325" cy="123858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069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13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20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278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348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41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487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4557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521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391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34697" y="194090"/>
            <a:ext cx="1407319" cy="4135349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2738" y="194090"/>
            <a:ext cx="4117710" cy="4135349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547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925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082" y="3114415"/>
            <a:ext cx="5316538" cy="962597"/>
          </a:xfrm>
        </p:spPr>
        <p:txBody>
          <a:bodyPr anchor="t"/>
          <a:lstStyle>
            <a:lvl1pPr algn="l">
              <a:defRPr sz="27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082" y="2054213"/>
            <a:ext cx="5316538" cy="1060202"/>
          </a:xfrm>
        </p:spPr>
        <p:txBody>
          <a:bodyPr anchor="b"/>
          <a:lstStyle>
            <a:lvl1pPr marL="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1pPr>
            <a:lvl2pPr marL="3069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1392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20892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22785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53482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84178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214874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45571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818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2737" y="1130884"/>
            <a:ext cx="2762515" cy="3198557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9501" y="1130884"/>
            <a:ext cx="2762515" cy="3198557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161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739" y="1084885"/>
            <a:ext cx="2763601" cy="45212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6964" indent="0">
              <a:buNone/>
              <a:defRPr sz="1300" b="1"/>
            </a:lvl2pPr>
            <a:lvl3pPr marL="613928" indent="0">
              <a:buNone/>
              <a:defRPr sz="1200" b="1"/>
            </a:lvl3pPr>
            <a:lvl4pPr marL="920892" indent="0">
              <a:buNone/>
              <a:defRPr sz="1100" b="1"/>
            </a:lvl4pPr>
            <a:lvl5pPr marL="1227856" indent="0">
              <a:buNone/>
              <a:defRPr sz="1100" b="1"/>
            </a:lvl5pPr>
            <a:lvl6pPr marL="1534820" indent="0">
              <a:buNone/>
              <a:defRPr sz="1100" b="1"/>
            </a:lvl6pPr>
            <a:lvl7pPr marL="1841784" indent="0">
              <a:buNone/>
              <a:defRPr sz="1100" b="1"/>
            </a:lvl7pPr>
            <a:lvl8pPr marL="2148749" indent="0">
              <a:buNone/>
              <a:defRPr sz="1100" b="1"/>
            </a:lvl8pPr>
            <a:lvl9pPr marL="2455713" indent="0">
              <a:buNone/>
              <a:defRPr sz="11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2739" y="1537014"/>
            <a:ext cx="2763601" cy="2792427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7327" y="1084885"/>
            <a:ext cx="2764686" cy="45212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6964" indent="0">
              <a:buNone/>
              <a:defRPr sz="1300" b="1"/>
            </a:lvl2pPr>
            <a:lvl3pPr marL="613928" indent="0">
              <a:buNone/>
              <a:defRPr sz="1200" b="1"/>
            </a:lvl3pPr>
            <a:lvl4pPr marL="920892" indent="0">
              <a:buNone/>
              <a:defRPr sz="1100" b="1"/>
            </a:lvl4pPr>
            <a:lvl5pPr marL="1227856" indent="0">
              <a:buNone/>
              <a:defRPr sz="1100" b="1"/>
            </a:lvl5pPr>
            <a:lvl6pPr marL="1534820" indent="0">
              <a:buNone/>
              <a:defRPr sz="1100" b="1"/>
            </a:lvl6pPr>
            <a:lvl7pPr marL="1841784" indent="0">
              <a:buNone/>
              <a:defRPr sz="1100" b="1"/>
            </a:lvl7pPr>
            <a:lvl8pPr marL="2148749" indent="0">
              <a:buNone/>
              <a:defRPr sz="1100" b="1"/>
            </a:lvl8pPr>
            <a:lvl9pPr marL="2455713" indent="0">
              <a:buNone/>
              <a:defRPr sz="11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7327" y="1537014"/>
            <a:ext cx="2764686" cy="2792427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773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08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4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2738" y="192970"/>
            <a:ext cx="2057770" cy="821235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5437" y="192970"/>
            <a:ext cx="3496579" cy="4136471"/>
          </a:xfrm>
        </p:spPr>
        <p:txBody>
          <a:bodyPr/>
          <a:lstStyle>
            <a:lvl1pPr>
              <a:defRPr sz="2100"/>
            </a:lvl1pPr>
            <a:lvl2pPr>
              <a:defRPr sz="19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2738" y="1014204"/>
            <a:ext cx="2057770" cy="3315236"/>
          </a:xfrm>
        </p:spPr>
        <p:txBody>
          <a:bodyPr/>
          <a:lstStyle>
            <a:lvl1pPr marL="0" indent="0">
              <a:buNone/>
              <a:defRPr sz="900"/>
            </a:lvl1pPr>
            <a:lvl2pPr marL="306964" indent="0">
              <a:buNone/>
              <a:defRPr sz="800"/>
            </a:lvl2pPr>
            <a:lvl3pPr marL="613928" indent="0">
              <a:buNone/>
              <a:defRPr sz="700"/>
            </a:lvl3pPr>
            <a:lvl4pPr marL="920892" indent="0">
              <a:buNone/>
              <a:defRPr sz="600"/>
            </a:lvl4pPr>
            <a:lvl5pPr marL="1227856" indent="0">
              <a:buNone/>
              <a:defRPr sz="600"/>
            </a:lvl5pPr>
            <a:lvl6pPr marL="1534820" indent="0">
              <a:buNone/>
              <a:defRPr sz="600"/>
            </a:lvl6pPr>
            <a:lvl7pPr marL="1841784" indent="0">
              <a:buNone/>
              <a:defRPr sz="600"/>
            </a:lvl7pPr>
            <a:lvl8pPr marL="2148749" indent="0">
              <a:buNone/>
              <a:defRPr sz="600"/>
            </a:lvl8pPr>
            <a:lvl9pPr marL="2455713" indent="0">
              <a:buNone/>
              <a:defRPr sz="6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720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5975" y="3392648"/>
            <a:ext cx="3752850" cy="400521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5975" y="433056"/>
            <a:ext cx="3752850" cy="2907983"/>
          </a:xfrm>
        </p:spPr>
        <p:txBody>
          <a:bodyPr/>
          <a:lstStyle>
            <a:lvl1pPr marL="0" indent="0">
              <a:buNone/>
              <a:defRPr sz="2100"/>
            </a:lvl1pPr>
            <a:lvl2pPr marL="306964" indent="0">
              <a:buNone/>
              <a:defRPr sz="1900"/>
            </a:lvl2pPr>
            <a:lvl3pPr marL="613928" indent="0">
              <a:buNone/>
              <a:defRPr sz="1600"/>
            </a:lvl3pPr>
            <a:lvl4pPr marL="920892" indent="0">
              <a:buNone/>
              <a:defRPr sz="1300"/>
            </a:lvl4pPr>
            <a:lvl5pPr marL="1227856" indent="0">
              <a:buNone/>
              <a:defRPr sz="1300"/>
            </a:lvl5pPr>
            <a:lvl6pPr marL="1534820" indent="0">
              <a:buNone/>
              <a:defRPr sz="1300"/>
            </a:lvl6pPr>
            <a:lvl7pPr marL="1841784" indent="0">
              <a:buNone/>
              <a:defRPr sz="1300"/>
            </a:lvl7pPr>
            <a:lvl8pPr marL="2148749" indent="0">
              <a:buNone/>
              <a:defRPr sz="1300"/>
            </a:lvl8pPr>
            <a:lvl9pPr marL="2455713" indent="0">
              <a:buNone/>
              <a:defRPr sz="13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5975" y="3793169"/>
            <a:ext cx="3752850" cy="568807"/>
          </a:xfrm>
        </p:spPr>
        <p:txBody>
          <a:bodyPr/>
          <a:lstStyle>
            <a:lvl1pPr marL="0" indent="0">
              <a:buNone/>
              <a:defRPr sz="900"/>
            </a:lvl1pPr>
            <a:lvl2pPr marL="306964" indent="0">
              <a:buNone/>
              <a:defRPr sz="800"/>
            </a:lvl2pPr>
            <a:lvl3pPr marL="613928" indent="0">
              <a:buNone/>
              <a:defRPr sz="700"/>
            </a:lvl3pPr>
            <a:lvl4pPr marL="920892" indent="0">
              <a:buNone/>
              <a:defRPr sz="600"/>
            </a:lvl4pPr>
            <a:lvl5pPr marL="1227856" indent="0">
              <a:buNone/>
              <a:defRPr sz="600"/>
            </a:lvl5pPr>
            <a:lvl6pPr marL="1534820" indent="0">
              <a:buNone/>
              <a:defRPr sz="600"/>
            </a:lvl6pPr>
            <a:lvl7pPr marL="1841784" indent="0">
              <a:buNone/>
              <a:defRPr sz="600"/>
            </a:lvl7pPr>
            <a:lvl8pPr marL="2148749" indent="0">
              <a:buNone/>
              <a:defRPr sz="600"/>
            </a:lvl8pPr>
            <a:lvl9pPr marL="2455713" indent="0">
              <a:buNone/>
              <a:defRPr sz="6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326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2741" y="194090"/>
            <a:ext cx="5629275" cy="807773"/>
          </a:xfrm>
          <a:prstGeom prst="rect">
            <a:avLst/>
          </a:prstGeom>
        </p:spPr>
        <p:txBody>
          <a:bodyPr vert="horz" lIns="61393" tIns="30696" rIns="61393" bIns="30696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741" y="1130884"/>
            <a:ext cx="5629275" cy="3198557"/>
          </a:xfrm>
          <a:prstGeom prst="rect">
            <a:avLst/>
          </a:prstGeom>
        </p:spPr>
        <p:txBody>
          <a:bodyPr vert="horz" lIns="61393" tIns="30696" rIns="61393" bIns="30696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2737" y="4492115"/>
            <a:ext cx="1459442" cy="258039"/>
          </a:xfrm>
          <a:prstGeom prst="rect">
            <a:avLst/>
          </a:prstGeom>
        </p:spPr>
        <p:txBody>
          <a:bodyPr vert="horz" lIns="61393" tIns="30696" rIns="61393" bIns="30696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E9563-3E64-E04C-8196-D6F3EFB2CDCC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37043" y="4492115"/>
            <a:ext cx="1980671" cy="258039"/>
          </a:xfrm>
          <a:prstGeom prst="rect">
            <a:avLst/>
          </a:prstGeom>
        </p:spPr>
        <p:txBody>
          <a:bodyPr vert="horz" lIns="61393" tIns="30696" rIns="61393" bIns="30696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2571" y="4492115"/>
            <a:ext cx="1459442" cy="258039"/>
          </a:xfrm>
          <a:prstGeom prst="rect">
            <a:avLst/>
          </a:prstGeom>
        </p:spPr>
        <p:txBody>
          <a:bodyPr vert="horz" lIns="61393" tIns="30696" rIns="61393" bIns="30696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1DE6B-2111-9743-A18C-19B6DC118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275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06964" rtl="0" eaLnBrk="1" latinLnBrk="0" hangingPunct="1">
        <a:spcBef>
          <a:spcPct val="0"/>
        </a:spcBef>
        <a:buNone/>
        <a:defRPr sz="3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0223" indent="-230223" algn="l" defTabSz="306964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498817" indent="-191853" algn="l" defTabSz="306964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767410" indent="-153482" algn="l" defTabSz="306964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74374" indent="-153482" algn="l" defTabSz="306964" rtl="0" eaLnBrk="1" latinLnBrk="0" hangingPunct="1">
        <a:spcBef>
          <a:spcPct val="20000"/>
        </a:spcBef>
        <a:buFont typeface="Arial"/>
        <a:buChar char="–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81338" indent="-153482" algn="l" defTabSz="306964" rtl="0" eaLnBrk="1" latinLnBrk="0" hangingPunct="1">
        <a:spcBef>
          <a:spcPct val="20000"/>
        </a:spcBef>
        <a:buFont typeface="Arial"/>
        <a:buChar char="»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88302" indent="-153482" algn="l" defTabSz="306964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95267" indent="-153482" algn="l" defTabSz="306964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02231" indent="-153482" algn="l" defTabSz="306964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609195" indent="-153482" algn="l" defTabSz="306964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6964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13928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20892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27856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34820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41784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48749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55713" algn="l" defTabSz="30696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3249" y="795348"/>
            <a:ext cx="6252114" cy="3265154"/>
            <a:chOff x="171604" y="191735"/>
            <a:chExt cx="6023610" cy="3145818"/>
          </a:xfrm>
        </p:grpSpPr>
        <p:pic>
          <p:nvPicPr>
            <p:cNvPr id="5" name="Picture 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604" y="191735"/>
              <a:ext cx="6023610" cy="2670175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171604" y="2861910"/>
              <a:ext cx="3481787" cy="4756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91" b="1" dirty="0"/>
                <a:t>Supplementary Figure S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23160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6144" y="4380346"/>
            <a:ext cx="32191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2</a:t>
            </a:r>
            <a:endParaRPr lang="en-US" sz="2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2117" y="2406026"/>
            <a:ext cx="2560799" cy="195942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1834" y="530939"/>
            <a:ext cx="2676263" cy="158661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01" y="530940"/>
            <a:ext cx="2675942" cy="1587782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6801255"/>
              </p:ext>
            </p:extLst>
          </p:nvPr>
        </p:nvGraphicFramePr>
        <p:xfrm>
          <a:off x="383635" y="2701770"/>
          <a:ext cx="1910712" cy="1493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55356"/>
                <a:gridCol w="955356"/>
              </a:tblGrid>
              <a:tr h="161076">
                <a:tc>
                  <a:txBody>
                    <a:bodyPr/>
                    <a:lstStyle/>
                    <a:p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Amylase (U/L)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NP1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3100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NP2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3650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NP3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3600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AP1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22500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AP2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25100</a:t>
                      </a:r>
                      <a:endParaRPr lang="en-GB" sz="800" dirty="0"/>
                    </a:p>
                  </a:txBody>
                  <a:tcPr/>
                </a:tc>
              </a:tr>
              <a:tr h="161076"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AP3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 smtClean="0"/>
                        <a:t>28350</a:t>
                      </a:r>
                      <a:endParaRPr lang="en-GB" sz="8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05134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54998" y="3538272"/>
            <a:ext cx="5153562" cy="534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718" dirty="0"/>
              <a:t>Heparin binding proteins isolated by using heparin affinity chromatography from mice normal pancreas. Murine plasma was diluted in PBS (1:4), and further diluted in H</a:t>
            </a:r>
            <a:r>
              <a:rPr lang="en-GB" sz="718" baseline="-25000" dirty="0"/>
              <a:t>2</a:t>
            </a:r>
            <a:r>
              <a:rPr lang="en-GB" sz="718" dirty="0"/>
              <a:t>O (1:2) and loaded onto a heparin column. The column was washed with PBS and further eluted using 2.15 M </a:t>
            </a:r>
            <a:r>
              <a:rPr lang="en-GB" sz="718" dirty="0" err="1"/>
              <a:t>NaCl</a:t>
            </a:r>
            <a:r>
              <a:rPr lang="en-GB" sz="718" dirty="0"/>
              <a:t>. Supernatant pre-loading onto the heparin column and the flow through were also examined and revealed that albumin levels decreased to negligible levels in the sample, which made effective MS analysis feasibl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3" t="6031" r="5688" b="18007"/>
          <a:stretch/>
        </p:blipFill>
        <p:spPr>
          <a:xfrm>
            <a:off x="578523" y="1258812"/>
            <a:ext cx="5153561" cy="22794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8910362">
            <a:off x="628825" y="880582"/>
            <a:ext cx="546150" cy="281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Protein Ladder </a:t>
            </a:r>
          </a:p>
        </p:txBody>
      </p:sp>
      <p:sp>
        <p:nvSpPr>
          <p:cNvPr id="5" name="TextBox 4"/>
          <p:cNvSpPr txBox="1"/>
          <p:nvPr/>
        </p:nvSpPr>
        <p:spPr>
          <a:xfrm rot="18910362">
            <a:off x="1184251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M </a:t>
            </a:r>
            <a:r>
              <a:rPr lang="en-GB" sz="616" b="1" dirty="0" err="1"/>
              <a:t>NaCl</a:t>
            </a:r>
            <a:r>
              <a:rPr lang="en-GB" sz="616" b="1" dirty="0"/>
              <a:t> </a:t>
            </a:r>
          </a:p>
        </p:txBody>
      </p:sp>
      <p:sp>
        <p:nvSpPr>
          <p:cNvPr id="6" name="TextBox 5"/>
          <p:cNvSpPr txBox="1"/>
          <p:nvPr/>
        </p:nvSpPr>
        <p:spPr>
          <a:xfrm rot="18910362">
            <a:off x="1738151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M </a:t>
            </a:r>
            <a:r>
              <a:rPr lang="en-GB" sz="616" b="1" dirty="0" err="1"/>
              <a:t>NaCl</a:t>
            </a:r>
            <a:r>
              <a:rPr lang="en-GB" sz="616" b="1" dirty="0"/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 rot="18910362">
            <a:off x="2239191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M </a:t>
            </a:r>
            <a:r>
              <a:rPr lang="en-GB" sz="616" b="1" dirty="0" err="1"/>
              <a:t>NaCl</a:t>
            </a:r>
            <a:r>
              <a:rPr lang="en-GB" sz="616" b="1" dirty="0"/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 rot="18910362">
            <a:off x="2800798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M </a:t>
            </a:r>
            <a:r>
              <a:rPr lang="en-GB" sz="616" b="1" dirty="0" err="1"/>
              <a:t>NaCl</a:t>
            </a:r>
            <a:r>
              <a:rPr lang="en-GB" sz="616" b="1" dirty="0"/>
              <a:t> </a:t>
            </a:r>
          </a:p>
        </p:txBody>
      </p:sp>
      <p:sp>
        <p:nvSpPr>
          <p:cNvPr id="9" name="TextBox 8"/>
          <p:cNvSpPr txBox="1"/>
          <p:nvPr/>
        </p:nvSpPr>
        <p:spPr>
          <a:xfrm rot="18910362">
            <a:off x="3255586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M </a:t>
            </a:r>
            <a:r>
              <a:rPr lang="en-GB" sz="616" b="1" dirty="0" err="1"/>
              <a:t>NaCl</a:t>
            </a:r>
            <a:r>
              <a:rPr lang="en-GB" sz="616" b="1" dirty="0"/>
              <a:t> </a:t>
            </a:r>
          </a:p>
        </p:txBody>
      </p:sp>
      <p:sp>
        <p:nvSpPr>
          <p:cNvPr id="10" name="TextBox 9"/>
          <p:cNvSpPr txBox="1"/>
          <p:nvPr/>
        </p:nvSpPr>
        <p:spPr>
          <a:xfrm rot="18910362">
            <a:off x="3770942" y="916531"/>
            <a:ext cx="671983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Wash </a:t>
            </a:r>
          </a:p>
        </p:txBody>
      </p:sp>
      <p:sp>
        <p:nvSpPr>
          <p:cNvPr id="11" name="TextBox 10"/>
          <p:cNvSpPr txBox="1"/>
          <p:nvPr/>
        </p:nvSpPr>
        <p:spPr>
          <a:xfrm rot="18910362">
            <a:off x="4324165" y="880175"/>
            <a:ext cx="775125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Supernatant </a:t>
            </a:r>
          </a:p>
        </p:txBody>
      </p:sp>
      <p:sp>
        <p:nvSpPr>
          <p:cNvPr id="12" name="TextBox 11"/>
          <p:cNvSpPr txBox="1"/>
          <p:nvPr/>
        </p:nvSpPr>
        <p:spPr>
          <a:xfrm rot="18910362">
            <a:off x="4807029" y="881487"/>
            <a:ext cx="771405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Flow through</a:t>
            </a:r>
          </a:p>
        </p:txBody>
      </p:sp>
      <p:sp>
        <p:nvSpPr>
          <p:cNvPr id="13" name="TextBox 12"/>
          <p:cNvSpPr txBox="1"/>
          <p:nvPr/>
        </p:nvSpPr>
        <p:spPr>
          <a:xfrm rot="18910362">
            <a:off x="5302732" y="817823"/>
            <a:ext cx="952018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2.15 M </a:t>
            </a:r>
            <a:r>
              <a:rPr lang="en-GB" sz="616" b="1" dirty="0" err="1"/>
              <a:t>NaCl</a:t>
            </a:r>
            <a:endParaRPr lang="en-GB" sz="616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15869" y="1488687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8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15869" y="2402285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25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15869" y="1610719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6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15869" y="1409677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10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15869" y="1760624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5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15869" y="2098356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3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15869" y="1919963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4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15869" y="1303958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15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15869" y="3259080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1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15869" y="2697218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20 </a:t>
            </a:r>
            <a:r>
              <a:rPr lang="en-GB" sz="616" b="1" dirty="0" err="1"/>
              <a:t>kDa</a:t>
            </a:r>
            <a:endParaRPr lang="en-GB" sz="616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177006" y="1628599"/>
            <a:ext cx="531554" cy="281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6" b="1" dirty="0"/>
              <a:t>← Albumi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144" y="4380346"/>
            <a:ext cx="32191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3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466346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4459" y="1345677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80 kD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54459" y="2314473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25 kD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4459" y="1474873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60 kD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4459" y="1243349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100 kD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54459" y="1639516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50 kD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4459" y="2009235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30 kD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4459" y="1814454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40 kD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4459" y="1122827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150 kD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4459" y="2617578"/>
            <a:ext cx="451046" cy="187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16" b="1" dirty="0"/>
              <a:t>20 kD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15432" y="3378883"/>
            <a:ext cx="3209588" cy="9452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616" b="1" dirty="0"/>
              <a:t>SDS-PAGE following heparin affinity chromatography and </a:t>
            </a:r>
            <a:r>
              <a:rPr lang="en-GB" sz="616" b="1" dirty="0" err="1"/>
              <a:t>StractaClean</a:t>
            </a:r>
            <a:r>
              <a:rPr lang="en-GB" sz="616" b="1" dirty="0"/>
              <a:t> adsorption. </a:t>
            </a:r>
            <a:r>
              <a:rPr lang="en-GB" sz="616" dirty="0"/>
              <a:t>Following elution off the heparin column using 2.15 M </a:t>
            </a:r>
            <a:r>
              <a:rPr lang="en-GB" sz="616" dirty="0" err="1"/>
              <a:t>NaCl</a:t>
            </a:r>
            <a:r>
              <a:rPr lang="en-GB" sz="616" dirty="0"/>
              <a:t> (lane HBPs pre-</a:t>
            </a:r>
            <a:r>
              <a:rPr lang="en-GB" sz="616" dirty="0" err="1"/>
              <a:t>StrataClean</a:t>
            </a:r>
            <a:r>
              <a:rPr lang="en-GB" sz="616" dirty="0"/>
              <a:t>), ~100 µg was adsorbed onto 30 µL of StrataClean (Agilent Technologies). The supernatant (lane post-StrataClean supernatant) was removed after </a:t>
            </a:r>
            <a:r>
              <a:rPr lang="en-GB" sz="616" dirty="0" err="1"/>
              <a:t>vortexing</a:t>
            </a:r>
            <a:r>
              <a:rPr lang="en-GB" sz="616" dirty="0"/>
              <a:t> for 2 min and centrifugation at 2,000 × g. StrataClean resin was then washed with PBS and spun down (lane post-StrataClean PBS wash). The pellet was finally </a:t>
            </a:r>
            <a:r>
              <a:rPr lang="en-GB" sz="616" dirty="0" err="1"/>
              <a:t>resupended</a:t>
            </a:r>
            <a:r>
              <a:rPr lang="en-GB" sz="616" dirty="0"/>
              <a:t> in 170 µL H</a:t>
            </a:r>
            <a:r>
              <a:rPr lang="en-GB" sz="616" baseline="-25000" dirty="0"/>
              <a:t>2</a:t>
            </a:r>
            <a:r>
              <a:rPr lang="en-GB" sz="616" dirty="0"/>
              <a:t>O, 150 µL for mass spectrometry (MS), and the rest (approx. 20 µL) was </a:t>
            </a:r>
            <a:r>
              <a:rPr lang="en-GB" sz="616" dirty="0" err="1"/>
              <a:t>resuspended</a:t>
            </a:r>
            <a:r>
              <a:rPr lang="en-GB" sz="616" dirty="0"/>
              <a:t> with 10 µL of 2 × </a:t>
            </a:r>
            <a:r>
              <a:rPr lang="en-GB" sz="616" dirty="0" err="1"/>
              <a:t>Laemmlli</a:t>
            </a:r>
            <a:r>
              <a:rPr lang="en-GB" sz="616" dirty="0"/>
              <a:t> buffer and boiled for 5 min (lane HBPs post-StrataClean). Samples were loaded onto 12% SDS-PAGE and stained using silver staining. 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65" t="3901" r="14065" b="19389"/>
          <a:stretch/>
        </p:blipFill>
        <p:spPr>
          <a:xfrm flipH="1">
            <a:off x="615432" y="1053379"/>
            <a:ext cx="3128810" cy="2292674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681373" y="814335"/>
            <a:ext cx="546150" cy="281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16" b="1" dirty="0"/>
              <a:t>Protein Ladder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292702" y="719565"/>
            <a:ext cx="527535" cy="3766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16" b="1" dirty="0"/>
              <a:t>HBPs pre-StrataClean (~1.0 µg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921169" y="624796"/>
            <a:ext cx="563799" cy="4714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16" b="1" dirty="0"/>
              <a:t>HBPs post-</a:t>
            </a:r>
            <a:r>
              <a:rPr lang="en-GB" sz="616" b="1" dirty="0" err="1"/>
              <a:t>StrataClean</a:t>
            </a:r>
            <a:endParaRPr lang="en-GB" sz="616" b="1" dirty="0"/>
          </a:p>
          <a:p>
            <a:pPr algn="ctr"/>
            <a:r>
              <a:rPr lang="en-GB" sz="616" b="1" dirty="0"/>
              <a:t>adsorption (~2.0 µg)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536384" y="624796"/>
            <a:ext cx="588616" cy="4714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16" b="1" dirty="0"/>
              <a:t>Post-StrataClean Supernatant (10 µL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76416" y="624796"/>
            <a:ext cx="572910" cy="4714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16" b="1" dirty="0"/>
              <a:t>Post-StrataClean PBS wash (10 µL)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144" y="4380346"/>
            <a:ext cx="32191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4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977131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335</Words>
  <Application>Microsoft Office PowerPoint</Application>
  <PresentationFormat>Custom</PresentationFormat>
  <Paragraphs>5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Liverpo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entin Nunes</dc:creator>
  <cp:lastModifiedBy>Su, Dunhao [dunhaosu]</cp:lastModifiedBy>
  <cp:revision>12</cp:revision>
  <dcterms:created xsi:type="dcterms:W3CDTF">2016-03-01T17:12:47Z</dcterms:created>
  <dcterms:modified xsi:type="dcterms:W3CDTF">2018-12-14T13:59:10Z</dcterms:modified>
</cp:coreProperties>
</file>